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788333-071A-4B32-8E3A-5CD33018E5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3AEECED-781D-4DD0-A9AE-53065B1A30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2B42DB-6275-45E1-9A40-F5522B558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4AED79-500B-414A-BCEA-8E1831AA1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55D4EB-AC8D-43F3-8B2E-7E69B393A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422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AA9378-583C-4DF6-8644-97C2D52852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23D933-AC06-4481-90C2-0C0063D0A6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636BF6-EAE2-4EDE-BF3A-4BA246DD8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F5AA08-2F28-4A63-AA90-1C3EE5BBC5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2C1D9C-59F9-47E1-98C7-C04B16F78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4802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D5E52A3-D9F0-47B0-914E-A95BEEDBBC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04BA0D-FE2B-480C-97E0-C768F1AE48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B3B1BE-1CC2-4A5E-8B73-D55D9A94C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0A1619-59C4-497E-9D48-D9A053023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0C27F5-59BC-43E5-8224-A45DCEB4D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75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FEED40-043C-4EF0-A115-FE74A6139F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61121D-AD85-4FE3-B11C-59DE07303D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3DD4249-518B-4225-866A-5BBCB9611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362C86-0ABF-476D-A26E-FE4CC1952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713A99-DE45-4F7E-AA88-E27F3B62E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107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CFBA17-4DE3-4655-AC9F-B3AD01C0CB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92F9FF-AFD5-42CD-B569-3F381AF316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72DB07-877F-4273-B6AB-E4839598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45A3B5-AB17-4B30-90EC-4CAB8B480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7CAF0B-2503-45FD-B1C7-6AA2DD26F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1888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AAB97C-8696-43F0-A09D-B6C501B333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6B1FD6-6A1C-416E-A774-C42152F32B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8FF58A-9231-4E24-891A-59DF03419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F97EC8-B0CA-4CFE-8FB2-B192FFE6B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A666C33-CD7E-40F9-AED0-1B61F51B6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D57E55-A762-48B3-90C9-CF5DD3CD2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9098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70D9D7-5FB1-41D2-931D-76290938C2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AD66BC-3A9E-4900-8A7C-5343A504A5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582F4DD-66A0-4DA5-8D86-DB9415D0CD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8DDEED5-A860-48F5-A4FE-7D62889DDE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EFAF253-A38F-47EE-BADD-49240D4D2E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31714E3-99EE-4843-9975-C053737E9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076399A-2513-488A-A883-0487FC513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C668B32-FF3A-4B0E-94A1-A63CF363D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5133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1E3AFF-EC66-4270-AC8F-28821E3DBB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357A176-3659-4045-809D-84DA65B30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16B8FA8-30FC-4CCB-8FC8-C4AAED9E0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3555613-550D-440C-8295-0CCD96F3F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8787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50DAFEC-BA11-4DC7-81AE-4F574F041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302A8C-9307-4AA6-8E89-972F3C10F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278209D-F44E-428B-A154-D8CD7C59C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066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45BA82-61E8-4EE9-B6F3-F0C62452C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5B6819-1C19-40A4-A18F-98CFDB1CBE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ADC42AF-C2B0-4864-BDEE-9DFE5DC428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94B2D4-DF30-4316-9E3D-1AD6C0DE5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55EFB05-B9AA-4D40-9AB4-BD1A3FAE0B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A69941-AFBB-42AE-80FF-DC6E318D5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992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DBD8ED-9115-44C5-BA6D-FBD7B692A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E2A54BF-C404-4E5E-A2A2-BCBF8F0659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0D298F-0C8B-43F9-91B2-77F572AF2A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ACF01B-A5F1-43E6-B955-925ADCF7E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853452-C30F-40C5-957F-AFF878F76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D2C5BC-B53E-43F6-8A03-AF6B5BAF4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4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364509F-DAD9-47F2-9346-28263A003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E56FE1-729A-4F78-A87E-918535EBB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CFCC64-A417-469D-8DBF-620F18F779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8FEEB-C8CE-465B-B16D-283E033325F3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110BC6-4346-4ADD-8C2E-F205BDBAC9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0D8323-C3AC-42E6-B354-16CFBBA69A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20953-58FE-42BD-89CB-BC98939873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650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13B4B2B-838C-4D1E-B1D6-8C5EB293EE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7813" y="559267"/>
            <a:ext cx="4277241" cy="583706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AE78933-6DF0-466C-A2B6-4DAC065F04CA}"/>
              </a:ext>
            </a:extLst>
          </p:cNvPr>
          <p:cNvSpPr txBox="1"/>
          <p:nvPr/>
        </p:nvSpPr>
        <p:spPr>
          <a:xfrm>
            <a:off x="339570" y="125104"/>
            <a:ext cx="4643248" cy="405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5. Weight comparison among different groups in NASH mice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BDCF442-39C7-476C-8FD7-8AD891E4F643}"/>
              </a:ext>
            </a:extLst>
          </p:cNvPr>
          <p:cNvSpPr txBox="1"/>
          <p:nvPr/>
        </p:nvSpPr>
        <p:spPr>
          <a:xfrm>
            <a:off x="71021" y="6396335"/>
            <a:ext cx="1173036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1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tervention groups: EHFD, exercise plus high fat diet; ELFD, exercise plus low fat diet; HFD, high fat diet; LFD, low fat diet; MCSM, methionine choline sufficient diet (4 weeks). None intervention groups: MCD, methionine choline deficiency diet (8 weeks); MCSC, methionine choline sufficient diet (8 weeks)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598968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a</dc:creator>
  <cp:lastModifiedBy>Wu Na</cp:lastModifiedBy>
  <cp:revision>7</cp:revision>
  <dcterms:created xsi:type="dcterms:W3CDTF">2021-04-26T05:10:10Z</dcterms:created>
  <dcterms:modified xsi:type="dcterms:W3CDTF">2021-08-16T11:31:31Z</dcterms:modified>
</cp:coreProperties>
</file>